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2EDE9-0009-DB2E-8B8E-5BC49077EC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A658EE-21DD-F5E9-F118-62B9F29B02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6436A7-6B1D-C4D8-59C4-C008C65A4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FF351-A2B5-F0F2-A1C6-3796EBB04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EC77BB-AE29-8E4D-A63C-9B0596791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3849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8A8A4-9C54-3959-264B-56FCA056E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60DF70-129C-7949-BF45-BF90AA7356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261A1-08A7-ED06-FFE8-3CC0C8285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1E22FC-7C7C-D17A-D9DB-A25E9B94C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54E0C7-24C9-51C6-DDED-97083E25E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303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E25683-72E8-CB1E-1BAC-A639ACD48B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45FC53-0EDF-F5E8-624A-3127C1B29D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ABB2BB-DFBC-E2B8-B3B2-5D3408DED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1CE76-74A8-34E6-1D2F-4568FA557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08ADD-4024-4EB3-7005-9B054B92E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6511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77EBCA-D675-AD88-3D70-E701A21CC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F8E765-56CC-E28D-6663-85A7C36C85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0F1177-1D8B-0A02-583F-3637767DC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ED6E40-3AC3-80A5-4764-B98312E8D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7F9E51-083D-30BB-8CEA-5414675D5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8241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B7923-B860-0B3C-E0C0-305A04F44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AADA8D-78DB-FE69-169E-A67F914A39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F4E1D4-E1C5-FB71-87A6-9EB3861C6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B1C050-95B3-EB68-48B0-5B27DBB79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97CE3-F739-A873-E25D-363E2E3E3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0422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C18D58-E7B5-D934-9D98-1F9D24E9B9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B76F87-0067-4A9E-5734-ED3D89F9CF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92F00A-084F-19B4-16AD-F377F24695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C9F950-8A70-3F84-45D6-6AC9BA20E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2ECB5C-0069-540F-49AA-B5E8513E8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2E2013-5797-9097-BA47-0FB8A3092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279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D4C02-5F2F-6C88-95D2-E4C0181CE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97E1E2-DFB7-0A2E-21CB-3B6D416FAA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0416DE-299A-666E-C323-056AEF6A81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951335-DEE5-8464-0E8D-555F0C7239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DCA6A7-E29E-10E0-F9E0-CDB037D62F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87A5DB9-EC11-A068-1224-735197501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16BB4F-87AF-FF09-C0CC-32D4769C0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F8F94C-0071-F5AE-5D52-24BB5C444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5659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3869E-85C0-9995-882E-D93A144E5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8EF165-FEF9-B1AB-1AC5-6D9BF6634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75AF74-A9B6-FE87-C579-4C2278AF4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571174-E31F-FAFF-EA3C-6263A0BB2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039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176A16-7A7F-6BF3-A2C4-5C4EF8F96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05183B-79D2-BC25-2538-032932634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565A9D-AE21-742F-A1EE-2F895394C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747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7DBA16-A976-38C6-CCDD-C7AC10AE7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E82718-F437-541E-D036-623C24913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4848F6-AD70-FB17-08B2-3EB7B3C51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01DBAB-529F-1680-B048-C5D1209F1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1491C6-9D13-61CB-1755-9CF2B4ADB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E51D55-A089-18B9-CC9C-27C38E51F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5962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CAA01-1FE5-5A1A-30A6-C2FD39466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E287B0-7FC1-3202-0FE2-16D7905F8D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E5CD85-69D5-5EF6-584A-4A81E60A2C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C9A9CA-1A42-7A7E-D271-229EC4C09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F167AE-D770-0B73-C4DE-33E262374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03A377-A2EF-C969-B177-95B716B19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96218A-920A-5611-499F-EA33DBE360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6023D3-D2E8-A10B-EF3D-226679023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07E97C-F44E-6FD6-DAE6-72CA9BB504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01C319-67A9-4965-B904-59A7486820BD}" type="datetimeFigureOut">
              <a:rPr lang="en-GB" smtClean="0"/>
              <a:t>1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FDBC2C-D1D7-5EC3-BD99-7900434DAC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5BA3ED-8EF3-1422-95CB-C6E462222D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EE23A6-A282-4A4D-A376-C98E3335552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088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4DDACDC-5D72-FF40-D70C-D3CD53E37D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1060413"/>
              </p:ext>
            </p:extLst>
          </p:nvPr>
        </p:nvGraphicFramePr>
        <p:xfrm>
          <a:off x="1131160" y="1037299"/>
          <a:ext cx="9144524" cy="4783401"/>
        </p:xfrm>
        <a:graphic>
          <a:graphicData uri="http://schemas.openxmlformats.org/drawingml/2006/table">
            <a:tbl>
              <a:tblPr/>
              <a:tblGrid>
                <a:gridCol w="724786">
                  <a:extLst>
                    <a:ext uri="{9D8B030D-6E8A-4147-A177-3AD203B41FA5}">
                      <a16:colId xmlns:a16="http://schemas.microsoft.com/office/drawing/2014/main" val="135094571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4026059925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4129837600"/>
                    </a:ext>
                  </a:extLst>
                </a:gridCol>
                <a:gridCol w="224934">
                  <a:extLst>
                    <a:ext uri="{9D8B030D-6E8A-4147-A177-3AD203B41FA5}">
                      <a16:colId xmlns:a16="http://schemas.microsoft.com/office/drawing/2014/main" val="1969344893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2940243525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1060662433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2550486666"/>
                    </a:ext>
                  </a:extLst>
                </a:gridCol>
                <a:gridCol w="111079">
                  <a:extLst>
                    <a:ext uri="{9D8B030D-6E8A-4147-A177-3AD203B41FA5}">
                      <a16:colId xmlns:a16="http://schemas.microsoft.com/office/drawing/2014/main" val="2920474742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2439280970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1315709905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2583900442"/>
                    </a:ext>
                  </a:extLst>
                </a:gridCol>
                <a:gridCol w="111079">
                  <a:extLst>
                    <a:ext uri="{9D8B030D-6E8A-4147-A177-3AD203B41FA5}">
                      <a16:colId xmlns:a16="http://schemas.microsoft.com/office/drawing/2014/main" val="181407939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3613269679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3086612040"/>
                    </a:ext>
                  </a:extLst>
                </a:gridCol>
                <a:gridCol w="724786">
                  <a:extLst>
                    <a:ext uri="{9D8B030D-6E8A-4147-A177-3AD203B41FA5}">
                      <a16:colId xmlns:a16="http://schemas.microsoft.com/office/drawing/2014/main" val="1745504255"/>
                    </a:ext>
                  </a:extLst>
                </a:gridCol>
              </a:tblGrid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70C0"/>
                          </a:solidFill>
                          <a:effectLst/>
                          <a:latin typeface="Helvetica" panose="020B0604020202020204"/>
                        </a:rPr>
                        <a:t>IL6/PHH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.val.adj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og2F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70C0"/>
                          </a:solidFill>
                          <a:effectLst/>
                          <a:latin typeface="Helvetica" panose="020B0604020202020204"/>
                        </a:rPr>
                        <a:t>IL2/PHH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.val.adj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og2F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70C0"/>
                          </a:solidFill>
                          <a:effectLst/>
                          <a:latin typeface="Helvetica" panose="020B0604020202020204"/>
                        </a:rPr>
                        <a:t>IL2/HL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.val.adj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og2F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70C0"/>
                          </a:solidFill>
                          <a:effectLst/>
                          <a:latin typeface="Helvetica" panose="020B0604020202020204"/>
                        </a:rPr>
                        <a:t>IL2/HepG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.val.adj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og2F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811802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LA2G2A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55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1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FAH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35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RAF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30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PP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60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1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0337862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D1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83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8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BHLHE4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11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7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NDRG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61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9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100A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8621860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TBR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35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6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DHRS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18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8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OL6A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37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6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ETV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4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330911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JUN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11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4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FURIN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20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7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ODC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97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1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NFRSF2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1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6462549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62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3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ISH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88E-1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6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AHNAK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84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1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PRED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0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249560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NHBE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9.29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7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63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8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T3GAL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53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8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BCL2L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17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683374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41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1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IF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07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5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LSCR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59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6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NCOA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4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2213247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EBI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1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9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TGAV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25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4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KAP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4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8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ENPP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0261779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RF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17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8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4R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75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1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WLS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64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4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RNP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7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96707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6ST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07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8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NFRSF1B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49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GALM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13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8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HK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23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4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288891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NFRSF1A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14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0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RAF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5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4HA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67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7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NFIL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36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1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69652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TAT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6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TSZ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29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2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TH1R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20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7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CLAT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8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4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747622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63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8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ECM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0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1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MPDL3A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58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6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HIPK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8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3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9489628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15RA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10E-1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7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A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52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9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MAP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9.94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8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SH3BGRL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94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7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8616482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CL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10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3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SF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0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8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BMP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16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6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ANXA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72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6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1922185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4R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75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1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ST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9.57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5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BATF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64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NT5E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53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3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979007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1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10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7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APN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95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4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TIH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69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1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KLF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93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3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3146270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L1B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5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6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RF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58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3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LAGL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43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9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NFKBIZ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84E-06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1698787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NFRSF1B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7.49E-1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5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FLT3LG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33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1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EEF1AKMT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07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8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MXD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6.01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8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761665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NTFR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25E-02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1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MAFF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91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HOPX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66E-0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8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ABCB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15E-08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7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9662421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63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1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GBP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09E-1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ENK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8E-05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4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8059967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SF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60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8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BATF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3.30E-0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4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956023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ITGB3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5.92E-0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1.97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583363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70C0"/>
                          </a:solidFill>
                          <a:effectLst/>
                          <a:latin typeface="Helvetica" panose="020B0604020202020204"/>
                        </a:rPr>
                        <a:t>IL6/iPS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p.val.adj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Log2FC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5456017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CXCL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2.27E-09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9.14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7808236"/>
                  </a:ext>
                </a:extLst>
              </a:tr>
              <a:tr h="17716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TNFRSF12A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4.75E-01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/>
                        </a:rPr>
                        <a:t>8.80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74" marR="7674" marT="76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40738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076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35</Words>
  <Application>Microsoft Office PowerPoint</Application>
  <PresentationFormat>Widescreen</PresentationFormat>
  <Paragraphs>4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Helvetica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leman, Saqlain</dc:creator>
  <cp:lastModifiedBy>Suleman, Saqlain</cp:lastModifiedBy>
  <cp:revision>2</cp:revision>
  <dcterms:created xsi:type="dcterms:W3CDTF">2025-05-15T15:59:15Z</dcterms:created>
  <dcterms:modified xsi:type="dcterms:W3CDTF">2025-05-19T11:26:45Z</dcterms:modified>
</cp:coreProperties>
</file>